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D312F7-B8AA-4FA7-9217-898583C52D5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FA3F47-1DF0-429B-8121-E9038DE90C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762FC8-A010-4D9C-BE72-A34EFB28005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A0EC9A-4E6E-4734-AD97-9A0BA30F437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CEAAF1-CBEB-4CD2-9137-CE9EEABBB3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AE95FA-0473-406B-9BAC-C3C16F2166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5DBFAA-4EF4-489A-8A67-D7AC0CDFCD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F8700E-FCB3-4D51-BD3A-86286D313A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D7A204-0215-4F79-85A1-DCB294DB85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D29070-4FB3-451E-934B-C5FF002AFE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235CF7-77BD-4B95-973D-F259462A5B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A84D89-702B-48CD-A7AA-87E57D6B22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971F01C-1AAE-46C0-A234-9A6F3916A7C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image" Target="../media/image5.png"/><Relationship Id="rId3" Type="http://schemas.openxmlformats.org/officeDocument/2006/relationships/image" Target="../media/image6.png"/><Relationship Id="rId4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nas3" descr=""/>
          <p:cNvPicPr/>
          <p:nvPr/>
        </p:nvPicPr>
        <p:blipFill>
          <a:blip r:embed="rId1"/>
          <a:srcRect l="4481" t="14014" r="12220" b="23715"/>
          <a:stretch/>
        </p:blipFill>
        <p:spPr>
          <a:xfrm>
            <a:off x="1569960" y="3184560"/>
            <a:ext cx="662040" cy="625320"/>
          </a:xfrm>
          <a:prstGeom prst="rect">
            <a:avLst/>
          </a:prstGeom>
          <a:ln w="0">
            <a:noFill/>
          </a:ln>
        </p:spPr>
      </p:pic>
      <p:pic>
        <p:nvPicPr>
          <p:cNvPr id="42" name="pnasred2" descr=""/>
          <p:cNvPicPr/>
          <p:nvPr/>
        </p:nvPicPr>
        <p:blipFill>
          <a:blip r:embed="rId2"/>
          <a:srcRect l="10550" t="10769" r="7136" b="16335"/>
          <a:stretch/>
        </p:blipFill>
        <p:spPr>
          <a:xfrm>
            <a:off x="2341440" y="2610000"/>
            <a:ext cx="432000" cy="41904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1220760" y="3067200"/>
            <a:ext cx="300240" cy="225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 flipV="1" rot="10800000">
            <a:off x="2244240" y="3500280"/>
            <a:ext cx="1535400" cy="270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7160" rIns="47160" tIns="23760" bIns="2376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Known domain interaction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2836800" y="2690640"/>
            <a:ext cx="800280" cy="27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7160" rIns="47160" tIns="23760" bIns="2376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Domain of</a:t>
            </a:r>
            <a:br>
              <a:rPr sz="900"/>
            </a:br>
            <a:r>
              <a:rPr b="0" lang="en-GB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protein B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79280" y="1897200"/>
            <a:ext cx="74628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7160" rIns="47160" tIns="23760" bIns="2376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Sequence </a:t>
            </a:r>
            <a:br>
              <a:rPr sz="900"/>
            </a:br>
            <a:r>
              <a:rPr b="0" lang="en-GB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protein A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2844720" y="1871640"/>
            <a:ext cx="74628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7160" rIns="47160" tIns="23760" bIns="2376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Sequence protein B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88920" y="2690640"/>
            <a:ext cx="955800" cy="27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7160" rIns="47160" tIns="23760" bIns="2376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Domain of</a:t>
            </a:r>
            <a:br>
              <a:rPr sz="900"/>
            </a:br>
            <a:r>
              <a:rPr b="0" lang="en-GB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protein 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nasgreen2" descr=""/>
          <p:cNvPicPr/>
          <p:nvPr/>
        </p:nvPicPr>
        <p:blipFill>
          <a:blip r:embed="rId3"/>
          <a:srcRect l="9727" t="0" r="17487" b="8577"/>
          <a:stretch/>
        </p:blipFill>
        <p:spPr>
          <a:xfrm>
            <a:off x="1035000" y="2644920"/>
            <a:ext cx="284040" cy="38232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927000" y="2016000"/>
            <a:ext cx="443160" cy="0"/>
          </a:xfrm>
          <a:prstGeom prst="line">
            <a:avLst/>
          </a:prstGeom>
          <a:ln w="57240">
            <a:solidFill>
              <a:srgbClr val="00cc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355840" y="2016000"/>
            <a:ext cx="442800" cy="0"/>
          </a:xfrm>
          <a:prstGeom prst="line">
            <a:avLst/>
          </a:prstGeom>
          <a:ln w="57240">
            <a:solidFill>
              <a:srgbClr val="cc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366920" y="2185920"/>
            <a:ext cx="1101600" cy="42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7160" rIns="47160" tIns="23760" bIns="2376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Assignment of </a:t>
            </a:r>
            <a:br>
              <a:rPr sz="900"/>
            </a:br>
            <a:r>
              <a:rPr b="0" lang="en-GB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domains</a:t>
            </a:r>
            <a:br>
              <a:rPr sz="900"/>
            </a:br>
            <a:r>
              <a:rPr b="0" lang="en-GB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by Threading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149480" y="2219400"/>
            <a:ext cx="0" cy="3394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577960" y="2203560"/>
            <a:ext cx="0" cy="33804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951200" y="3857760"/>
            <a:ext cx="0" cy="70488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043000" y="4057560"/>
            <a:ext cx="72864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7160" rIns="47160" tIns="23760" bIns="237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Hypothesi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flipH="1">
            <a:off x="2260440" y="3067200"/>
            <a:ext cx="300240" cy="2253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690560" y="4648320"/>
            <a:ext cx="722520" cy="129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7160" rIns="47160" tIns="23760" bIns="237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Interact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9" name=""/>
          <p:cNvGrpSpPr/>
          <p:nvPr/>
        </p:nvGrpSpPr>
        <p:grpSpPr>
          <a:xfrm>
            <a:off x="2340000" y="4633920"/>
            <a:ext cx="893880" cy="379440"/>
            <a:chOff x="2340000" y="4633920"/>
            <a:chExt cx="893880" cy="379440"/>
          </a:xfrm>
        </p:grpSpPr>
        <p:sp>
          <p:nvSpPr>
            <p:cNvPr id="60" name=""/>
            <p:cNvSpPr/>
            <p:nvPr/>
          </p:nvSpPr>
          <p:spPr>
            <a:xfrm>
              <a:off x="2340000" y="4633920"/>
              <a:ext cx="443160" cy="1800"/>
            </a:xfrm>
            <a:prstGeom prst="line">
              <a:avLst/>
            </a:prstGeom>
            <a:ln w="57240">
              <a:solidFill>
                <a:srgbClr val="cc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340000" y="4705560"/>
              <a:ext cx="893880" cy="307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7160" rIns="47160" tIns="23760" bIns="23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rotein B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2" name=""/>
          <p:cNvGrpSpPr/>
          <p:nvPr/>
        </p:nvGrpSpPr>
        <p:grpSpPr>
          <a:xfrm>
            <a:off x="1116000" y="4633920"/>
            <a:ext cx="576360" cy="289080"/>
            <a:chOff x="1116000" y="4633920"/>
            <a:chExt cx="576360" cy="289080"/>
          </a:xfrm>
        </p:grpSpPr>
        <p:sp>
          <p:nvSpPr>
            <p:cNvPr id="63" name=""/>
            <p:cNvSpPr/>
            <p:nvPr/>
          </p:nvSpPr>
          <p:spPr>
            <a:xfrm>
              <a:off x="1116000" y="4633920"/>
              <a:ext cx="442800" cy="0"/>
            </a:xfrm>
            <a:prstGeom prst="line">
              <a:avLst/>
            </a:prstGeom>
            <a:ln w="57240">
              <a:solidFill>
                <a:srgbClr val="00cc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116000" y="4707000"/>
              <a:ext cx="576360" cy="216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47160" rIns="47160" tIns="23760" bIns="2376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Protein 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5" name=""/>
          <p:cNvSpPr/>
          <p:nvPr/>
        </p:nvSpPr>
        <p:spPr>
          <a:xfrm>
            <a:off x="250920" y="692280"/>
            <a:ext cx="2808360" cy="342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tructural based prediction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0" y="1604880"/>
            <a:ext cx="3772080" cy="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-46440" bIns="-4644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0" y="1490760"/>
            <a:ext cx="1843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620720" y="4633920"/>
            <a:ext cx="64764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79280" y="620640"/>
            <a:ext cx="3672000" cy="5472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6281640" y="3860640"/>
            <a:ext cx="522360" cy="646200"/>
          </a:xfrm>
          <a:prstGeom prst="flowChartMagneticDisk">
            <a:avLst/>
          </a:prstGeom>
          <a:solidFill>
            <a:srgbClr val="ffcc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5848200" y="3889440"/>
            <a:ext cx="522360" cy="649080"/>
          </a:xfrm>
          <a:prstGeom prst="flowChartMagneticDisk">
            <a:avLst/>
          </a:prstGeom>
          <a:solidFill>
            <a:srgbClr val="ff99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4960800" y="1969920"/>
            <a:ext cx="10018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Protein 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6827760" y="1969920"/>
            <a:ext cx="10033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Protein B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4989600" y="3349800"/>
            <a:ext cx="95256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Protein A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'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6838920" y="3349800"/>
            <a:ext cx="98100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Protein B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'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 flipH="1">
            <a:off x="5795640" y="3429000"/>
            <a:ext cx="1152360" cy="0"/>
          </a:xfrm>
          <a:prstGeom prst="line">
            <a:avLst/>
          </a:prstGeom>
          <a:ln w="6480">
            <a:solidFill>
              <a:srgbClr val="000000"/>
            </a:solidFill>
            <a:prstDash val="dash"/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5364000" y="4538520"/>
            <a:ext cx="201636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Interaction  according to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Interaction databases </a:t>
            </a:r>
            <a:br>
              <a:rPr sz="900"/>
            </a:b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(Netpro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5651640" y="2421000"/>
            <a:ext cx="151128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Orthologue information (BLAST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4645080" y="692280"/>
            <a:ext cx="2303280" cy="342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equence based predic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0" name=""/>
          <p:cNvCxnSpPr>
            <a:stCxn id="72" idx="2"/>
            <a:endCxn id="74" idx="0"/>
          </p:cNvCxnSpPr>
          <p:nvPr/>
        </p:nvCxnSpPr>
        <p:spPr>
          <a:xfrm flipH="1" rot="16200000">
            <a:off x="4888080" y="2772000"/>
            <a:ext cx="1151640" cy="4680"/>
          </a:xfrm>
          <a:prstGeom prst="bentConnector3">
            <a:avLst>
              <a:gd name="adj1" fmla="val 50000"/>
            </a:avLst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81" name=""/>
          <p:cNvCxnSpPr>
            <a:stCxn id="73" idx="2"/>
            <a:endCxn id="75" idx="0"/>
          </p:cNvCxnSpPr>
          <p:nvPr/>
        </p:nvCxnSpPr>
        <p:spPr>
          <a:xfrm rot="16200000">
            <a:off x="6753600" y="2774160"/>
            <a:ext cx="1151640" cy="360"/>
          </a:xfrm>
          <a:prstGeom prst="bentConnector2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82" name=""/>
          <p:cNvSpPr/>
          <p:nvPr/>
        </p:nvSpPr>
        <p:spPr>
          <a:xfrm>
            <a:off x="4572000" y="620640"/>
            <a:ext cx="3672000" cy="5472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1476360" y="1484280"/>
            <a:ext cx="86364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1332000" y="1197000"/>
            <a:ext cx="12240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7160" rIns="47160" tIns="23760" bIns="2376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Unknown Interact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468360" y="1341360"/>
            <a:ext cx="10015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Protein 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2335320" y="1341360"/>
            <a:ext cx="10033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Protein B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5796000" y="1197000"/>
            <a:ext cx="12240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7160" rIns="47160" tIns="23760" bIns="2376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Unknown Interaction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5940360" y="1484280"/>
            <a:ext cx="86364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4932360" y="1413000"/>
            <a:ext cx="100188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Protein 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6799320" y="1413000"/>
            <a:ext cx="1003320" cy="228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Protein B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6012000" y="3429000"/>
            <a:ext cx="728640" cy="15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47160" rIns="47160" tIns="23760" bIns="237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Hypothesi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111960" y="115920"/>
            <a:ext cx="3236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Supplemental information 2 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3" name="" descr=""/>
          <p:cNvPicPr/>
          <p:nvPr/>
        </p:nvPicPr>
        <p:blipFill>
          <a:blip r:embed="rId1"/>
          <a:stretch/>
        </p:blipFill>
        <p:spPr>
          <a:xfrm>
            <a:off x="468360" y="971640"/>
            <a:ext cx="2663640" cy="2340000"/>
          </a:xfrm>
          <a:prstGeom prst="rect">
            <a:avLst/>
          </a:prstGeom>
          <a:ln w="0">
            <a:noFill/>
          </a:ln>
        </p:spPr>
      </p:pic>
      <p:sp>
        <p:nvSpPr>
          <p:cNvPr id="94" name=""/>
          <p:cNvSpPr/>
          <p:nvPr/>
        </p:nvSpPr>
        <p:spPr>
          <a:xfrm>
            <a:off x="665640" y="97488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5" name="" descr=""/>
          <p:cNvPicPr/>
          <p:nvPr/>
        </p:nvPicPr>
        <p:blipFill>
          <a:blip r:embed="rId2"/>
          <a:stretch/>
        </p:blipFill>
        <p:spPr>
          <a:xfrm>
            <a:off x="3203640" y="692280"/>
            <a:ext cx="2763720" cy="2427120"/>
          </a:xfrm>
          <a:prstGeom prst="rect">
            <a:avLst/>
          </a:prstGeom>
          <a:ln w="0">
            <a:noFill/>
          </a:ln>
        </p:spPr>
      </p:pic>
      <p:sp>
        <p:nvSpPr>
          <p:cNvPr id="96" name=""/>
          <p:cNvSpPr/>
          <p:nvPr/>
        </p:nvSpPr>
        <p:spPr>
          <a:xfrm>
            <a:off x="3402360" y="97488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7" name="" descr=""/>
          <p:cNvPicPr/>
          <p:nvPr/>
        </p:nvPicPr>
        <p:blipFill>
          <a:blip r:embed="rId3"/>
          <a:stretch/>
        </p:blipFill>
        <p:spPr>
          <a:xfrm>
            <a:off x="6227640" y="1052640"/>
            <a:ext cx="2737080" cy="2404800"/>
          </a:xfrm>
          <a:prstGeom prst="rect">
            <a:avLst/>
          </a:prstGeom>
          <a:ln w="0">
            <a:noFill/>
          </a:ln>
        </p:spPr>
      </p:pic>
      <p:sp>
        <p:nvSpPr>
          <p:cNvPr id="98" name=""/>
          <p:cNvSpPr/>
          <p:nvPr/>
        </p:nvSpPr>
        <p:spPr>
          <a:xfrm>
            <a:off x="6134400" y="98100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612720" y="907920"/>
            <a:ext cx="2664000" cy="2449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468360" y="765000"/>
            <a:ext cx="0" cy="3240360"/>
          </a:xfrm>
          <a:prstGeom prst="line">
            <a:avLst/>
          </a:prstGeom>
          <a:ln w="7632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3348000" y="907920"/>
            <a:ext cx="2664000" cy="2449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6084720" y="907920"/>
            <a:ext cx="2664000" cy="2449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111960" y="115920"/>
            <a:ext cx="3236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000000"/>
                </a:solidFill>
                <a:latin typeface="Arial"/>
              </a:rPr>
              <a:t>Supplemental information 2 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24T08:27:59Z</dcterms:created>
  <dc:creator>F. Rückert</dc:creator>
  <dc:description/>
  <dc:language>en-US</dc:language>
  <cp:lastModifiedBy>FR</cp:lastModifiedBy>
  <dcterms:modified xsi:type="dcterms:W3CDTF">2010-06-25T16:22:21Z</dcterms:modified>
  <cp:revision>10</cp:revision>
  <dc:subject/>
  <dc:title>Folie 1</dc:title>
</cp:coreProperties>
</file>